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 snapToObjects="1">
      <p:cViewPr varScale="1">
        <p:scale>
          <a:sx n="104" d="100"/>
          <a:sy n="104" d="100"/>
        </p:scale>
        <p:origin x="232" y="5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F5D557-EA03-7440-93D6-0F1ABFD620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FB232EE-33FE-E14A-8301-19F817CD78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DB968B-8528-0140-B2A8-6E7966F79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81A4E-50A1-4A49-8DB0-58E155B85AFC}" type="datetimeFigureOut">
              <a:rPr lang="en-US" smtClean="0"/>
              <a:t>7/1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B49288-EC07-5F43-9669-CDF9B80D4C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CF4323-75E7-A34E-94C4-F19F5A108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9301-87F6-BE4F-BE57-8BF7C1CC60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362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0A2FDC-0C70-4B45-A73B-29377B272E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D996B90-6AF5-8C47-877C-8FD38E87BD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F61CEC-541C-B247-93CD-1C5D896027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81A4E-50A1-4A49-8DB0-58E155B85AFC}" type="datetimeFigureOut">
              <a:rPr lang="en-US" smtClean="0"/>
              <a:t>7/1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CBD55F-1237-054F-904C-9295CC8257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4AD6E0-2D23-6D46-9251-F5A01600D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9301-87F6-BE4F-BE57-8BF7C1CC60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098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D5FBC1A-4CD2-6E41-A37F-27CA541681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CF1312-21F2-2B4D-8B05-4666AE75E6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1EAA9D-0711-EF47-B311-BFE772554B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81A4E-50A1-4A49-8DB0-58E155B85AFC}" type="datetimeFigureOut">
              <a:rPr lang="en-US" smtClean="0"/>
              <a:t>7/1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C865F1-A6C4-4444-A962-A6A54274E6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403BC3-ADDC-FF45-A036-3DC26642DF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9301-87F6-BE4F-BE57-8BF7C1CC60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098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407DDB-6BD9-D04F-875D-8CA6A6BB7B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D2567E-A1FD-934E-844A-2B77E88D15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6C376A-8C56-C641-90F1-ACA2E7EE9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81A4E-50A1-4A49-8DB0-58E155B85AFC}" type="datetimeFigureOut">
              <a:rPr lang="en-US" smtClean="0"/>
              <a:t>7/1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B2CD55-00BC-8B44-98FF-60A34EB040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F3FB35-B93F-3740-97D6-C004CE3C8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9301-87F6-BE4F-BE57-8BF7C1CC60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996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DA8EE9-BDFF-3544-B0B4-1C7E24498B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9C07B5-0486-6944-901C-4D753DB390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F7843B-D390-B449-9730-0E61D88623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81A4E-50A1-4A49-8DB0-58E155B85AFC}" type="datetimeFigureOut">
              <a:rPr lang="en-US" smtClean="0"/>
              <a:t>7/1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ED4EE0-44BD-C94D-9D6E-4CCA7A2879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3CEA3A-0F98-0044-A5A7-6F3606B58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9301-87F6-BE4F-BE57-8BF7C1CC60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1479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0D5D71-178C-9045-8874-45BEE0E6A0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C8DDAC-D659-D941-8514-2C42A70B48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F686ECF-D03F-FC43-B423-EC52C52336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23F27C-1F10-2848-8D76-4F2B72E2A7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81A4E-50A1-4A49-8DB0-58E155B85AFC}" type="datetimeFigureOut">
              <a:rPr lang="en-US" smtClean="0"/>
              <a:t>7/1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9E264A-74FD-D94F-89AC-D0C85B38D0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DDC676-9B27-774F-B574-27E59EE81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9301-87F6-BE4F-BE57-8BF7C1CC60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024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177449-0E2A-7547-A1DD-329B52C898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A0E96C-DC71-B64E-AF9D-A92CF42C95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004252E-9E64-BE46-B2ED-0FFEC2FA1A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17A4E6B-B6D4-1145-A1A1-65872BFEDD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D5CC6AB-4E8D-3F4F-A99D-B661046B85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910EFBD-2663-4240-AD41-DFE4E7BAD2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81A4E-50A1-4A49-8DB0-58E155B85AFC}" type="datetimeFigureOut">
              <a:rPr lang="en-US" smtClean="0"/>
              <a:t>7/17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C992B8C-1075-0D4A-A867-60DAB059D2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0496A30-15AF-E240-A402-DE18443D3F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9301-87F6-BE4F-BE57-8BF7C1CC60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709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5E3146-54E5-084B-888C-48C39A0723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89748BA-F23B-7F44-92B0-ED0C8B55B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81A4E-50A1-4A49-8DB0-58E155B85AFC}" type="datetimeFigureOut">
              <a:rPr lang="en-US" smtClean="0"/>
              <a:t>7/17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B62548E-AB78-CC48-9AFD-75ECFCAE9B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DFF024E-BA6D-174C-B5F5-D44CB0EFCF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9301-87F6-BE4F-BE57-8BF7C1CC60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670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46C9D01-7057-2542-9029-85B4AD793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81A4E-50A1-4A49-8DB0-58E155B85AFC}" type="datetimeFigureOut">
              <a:rPr lang="en-US" smtClean="0"/>
              <a:t>7/17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9DD62E-0FE3-3D42-B65E-BC5ED5496E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39C4296-38E5-7E44-98C6-E26C5BBC6A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9301-87F6-BE4F-BE57-8BF7C1CC60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467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A099A5-AFA0-FA4B-9785-18F59A6202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B3DCD3-F3C0-E047-958A-1A32AA03A3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ACBA13-B10F-C044-8E45-311585F93D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9C91F4-E131-F740-96A4-F51B76CB9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81A4E-50A1-4A49-8DB0-58E155B85AFC}" type="datetimeFigureOut">
              <a:rPr lang="en-US" smtClean="0"/>
              <a:t>7/1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D8239E-5867-944C-A2CB-E82788754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FCDA32-BF2D-2145-9D5D-ED3CE3AB6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9301-87F6-BE4F-BE57-8BF7C1CC60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282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798D76-9D5D-9749-8755-56A111D96D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D6D491F-86A2-EA48-9F85-45018928D3D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934AF9-0B51-3D4F-B2C2-BCBE16CA14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120150-0A6B-DB45-9F1E-6D9B63AD1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81A4E-50A1-4A49-8DB0-58E155B85AFC}" type="datetimeFigureOut">
              <a:rPr lang="en-US" smtClean="0"/>
              <a:t>7/1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7A6ADD-972B-6647-AF28-56FA3290A2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C231DB-2DF7-F346-A62D-AAF12CC05F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9301-87F6-BE4F-BE57-8BF7C1CC60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45508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116A4BC-050E-FF48-A654-7AEE6E64BA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568F9E-8A96-2445-8067-B1C60EDE80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BA565F-287E-3C42-8FD5-B9A81C7293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E81A4E-50A1-4A49-8DB0-58E155B85AFC}" type="datetimeFigureOut">
              <a:rPr lang="en-US" smtClean="0"/>
              <a:t>7/1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E25184-67C4-424A-A3E1-FFCFFDBF20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3274FB-2855-C647-BE3B-6B5505A4D9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819301-87F6-BE4F-BE57-8BF7C1CC60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395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bar chart&#10;&#10;Description automatically generated">
            <a:extLst>
              <a:ext uri="{FF2B5EF4-FFF2-40B4-BE49-F238E27FC236}">
                <a16:creationId xmlns:a16="http://schemas.microsoft.com/office/drawing/2014/main" id="{5ACA7617-5D46-6649-A176-982457770B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667594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A990977-7222-624F-B565-1508B30B25CD}"/>
              </a:ext>
            </a:extLst>
          </p:cNvPr>
          <p:cNvSpPr txBox="1"/>
          <p:nvPr/>
        </p:nvSpPr>
        <p:spPr>
          <a:xfrm>
            <a:off x="8180174" y="4769709"/>
            <a:ext cx="375645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1: Total Assays Per Chemical by Activity. </a:t>
            </a:r>
            <a:r>
              <a:rPr lang="en-US" dirty="0"/>
              <a:t>Visualization of total number of assays run for each chemical colored by ratio of active to total assays.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5548446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30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lemi, Katelyn</dc:creator>
  <cp:lastModifiedBy>Polemi, Katelyn</cp:lastModifiedBy>
  <cp:revision>2</cp:revision>
  <dcterms:created xsi:type="dcterms:W3CDTF">2021-07-17T12:57:44Z</dcterms:created>
  <dcterms:modified xsi:type="dcterms:W3CDTF">2021-07-17T13:08:32Z</dcterms:modified>
</cp:coreProperties>
</file>